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82" r:id="rId5"/>
    <p:sldId id="283" r:id="rId6"/>
    <p:sldId id="299" r:id="rId7"/>
    <p:sldId id="300" r:id="rId8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21" d="100"/>
          <a:sy n="121" d="100"/>
        </p:scale>
        <p:origin x="1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copo Boni" userId="3468928e-f576-476d-811b-ea8091bad45a" providerId="ADAL" clId="{A57800CA-4072-4B01-99D3-B58C761CB754}"/>
    <pc:docChg chg="undo custSel addSld delSld modSld">
      <pc:chgData name="Jacopo Boni" userId="3468928e-f576-476d-811b-ea8091bad45a" providerId="ADAL" clId="{A57800CA-4072-4B01-99D3-B58C761CB754}" dt="2025-07-25T13:30:17.809" v="327" actId="14100"/>
      <pc:docMkLst>
        <pc:docMk/>
      </pc:docMkLst>
      <pc:sldChg chg="modSp mod">
        <pc:chgData name="Jacopo Boni" userId="3468928e-f576-476d-811b-ea8091bad45a" providerId="ADAL" clId="{A57800CA-4072-4B01-99D3-B58C761CB754}" dt="2025-07-25T13:11:22.803" v="181" actId="14100"/>
        <pc:sldMkLst>
          <pc:docMk/>
          <pc:sldMk cId="1899656772" sldId="257"/>
        </pc:sldMkLst>
      </pc:sldChg>
      <pc:sldChg chg="addSp delSp modSp mod">
        <pc:chgData name="Jacopo Boni" userId="3468928e-f576-476d-811b-ea8091bad45a" providerId="ADAL" clId="{A57800CA-4072-4B01-99D3-B58C761CB754}" dt="2025-07-25T12:33:10.854" v="113" actId="732"/>
        <pc:sldMkLst>
          <pc:docMk/>
          <pc:sldMk cId="849156004" sldId="276"/>
        </pc:sldMkLst>
      </pc:sldChg>
      <pc:sldChg chg="addSp modSp mod">
        <pc:chgData name="Jacopo Boni" userId="3468928e-f576-476d-811b-ea8091bad45a" providerId="ADAL" clId="{A57800CA-4072-4B01-99D3-B58C761CB754}" dt="2025-07-25T13:27:02.726" v="320" actId="1076"/>
        <pc:sldMkLst>
          <pc:docMk/>
          <pc:sldMk cId="989154112" sldId="278"/>
        </pc:sldMkLst>
      </pc:sldChg>
      <pc:sldChg chg="addSp delSp modSp mod">
        <pc:chgData name="Jacopo Boni" userId="3468928e-f576-476d-811b-ea8091bad45a" providerId="ADAL" clId="{A57800CA-4072-4B01-99D3-B58C761CB754}" dt="2025-07-25T13:30:17.809" v="327" actId="14100"/>
        <pc:sldMkLst>
          <pc:docMk/>
          <pc:sldMk cId="1574192415" sldId="279"/>
        </pc:sldMkLst>
      </pc:sldChg>
      <pc:sldChg chg="addSp delSp modSp add del mod">
        <pc:chgData name="Jacopo Boni" userId="3468928e-f576-476d-811b-ea8091bad45a" providerId="ADAL" clId="{A57800CA-4072-4B01-99D3-B58C761CB754}" dt="2025-07-25T12:51:25.652" v="163" actId="478"/>
        <pc:sldMkLst>
          <pc:docMk/>
          <pc:sldMk cId="2685193683" sldId="282"/>
        </pc:sldMkLst>
      </pc:sldChg>
      <pc:sldChg chg="addSp modSp add del mod">
        <pc:chgData name="Jacopo Boni" userId="3468928e-f576-476d-811b-ea8091bad45a" providerId="ADAL" clId="{A57800CA-4072-4B01-99D3-B58C761CB754}" dt="2025-07-25T12:56:35.608" v="175" actId="1076"/>
        <pc:sldMkLst>
          <pc:docMk/>
          <pc:sldMk cId="3959166534" sldId="283"/>
        </pc:sldMkLst>
      </pc:sldChg>
      <pc:sldChg chg="addSp delSp modSp mod">
        <pc:chgData name="Jacopo Boni" userId="3468928e-f576-476d-811b-ea8091bad45a" providerId="ADAL" clId="{A57800CA-4072-4B01-99D3-B58C761CB754}" dt="2025-07-25T12:30:28.818" v="82" actId="478"/>
        <pc:sldMkLst>
          <pc:docMk/>
          <pc:sldMk cId="2388881966" sldId="286"/>
        </pc:sldMkLst>
      </pc:sldChg>
      <pc:sldChg chg="delSp modSp mod">
        <pc:chgData name="Jacopo Boni" userId="3468928e-f576-476d-811b-ea8091bad45a" providerId="ADAL" clId="{A57800CA-4072-4B01-99D3-B58C761CB754}" dt="2025-07-25T12:30:35.389" v="84" actId="478"/>
        <pc:sldMkLst>
          <pc:docMk/>
          <pc:sldMk cId="3491293808" sldId="292"/>
        </pc:sldMkLst>
      </pc:sldChg>
      <pc:sldChg chg="delSp mod">
        <pc:chgData name="Jacopo Boni" userId="3468928e-f576-476d-811b-ea8091bad45a" providerId="ADAL" clId="{A57800CA-4072-4B01-99D3-B58C761CB754}" dt="2025-07-25T12:30:33.021" v="83" actId="478"/>
        <pc:sldMkLst>
          <pc:docMk/>
          <pc:sldMk cId="1938919551" sldId="293"/>
        </pc:sldMkLst>
      </pc:sldChg>
      <pc:sldChg chg="delSp modSp mod">
        <pc:chgData name="Jacopo Boni" userId="3468928e-f576-476d-811b-ea8091bad45a" providerId="ADAL" clId="{A57800CA-4072-4B01-99D3-B58C761CB754}" dt="2025-07-25T12:30:43.190" v="85" actId="478"/>
        <pc:sldMkLst>
          <pc:docMk/>
          <pc:sldMk cId="2278150265" sldId="294"/>
        </pc:sldMkLst>
      </pc:sldChg>
      <pc:sldChg chg="addSp delSp modSp add mod">
        <pc:chgData name="Jacopo Boni" userId="3468928e-f576-476d-811b-ea8091bad45a" providerId="ADAL" clId="{A57800CA-4072-4B01-99D3-B58C761CB754}" dt="2025-07-25T12:56:18.031" v="174" actId="14100"/>
        <pc:sldMkLst>
          <pc:docMk/>
          <pc:sldMk cId="1510078259" sldId="299"/>
        </pc:sldMkLst>
      </pc:sldChg>
      <pc:sldChg chg="addSp delSp modSp add mod">
        <pc:chgData name="Jacopo Boni" userId="3468928e-f576-476d-811b-ea8091bad45a" providerId="ADAL" clId="{A57800CA-4072-4B01-99D3-B58C761CB754}" dt="2025-07-25T12:54:58.422" v="169" actId="14100"/>
        <pc:sldMkLst>
          <pc:docMk/>
          <pc:sldMk cId="1256841142" sldId="300"/>
        </pc:sldMkLst>
      </pc:sldChg>
      <pc:sldChg chg="addSp delSp modSp add mod">
        <pc:chgData name="Jacopo Boni" userId="3468928e-f576-476d-811b-ea8091bad45a" providerId="ADAL" clId="{A57800CA-4072-4B01-99D3-B58C761CB754}" dt="2025-07-25T13:17:18.484" v="257" actId="1076"/>
        <pc:sldMkLst>
          <pc:docMk/>
          <pc:sldMk cId="1296663075" sldId="301"/>
        </pc:sldMkLst>
      </pc:sldChg>
      <pc:sldChg chg="delSp modSp add mod">
        <pc:chgData name="Jacopo Boni" userId="3468928e-f576-476d-811b-ea8091bad45a" providerId="ADAL" clId="{A57800CA-4072-4B01-99D3-B58C761CB754}" dt="2025-07-25T13:16:46.474" v="250" actId="1035"/>
        <pc:sldMkLst>
          <pc:docMk/>
          <pc:sldMk cId="2571517090" sldId="302"/>
        </pc:sldMkLst>
      </pc:sldChg>
      <pc:sldChg chg="addSp delSp modSp add mod">
        <pc:chgData name="Jacopo Boni" userId="3468928e-f576-476d-811b-ea8091bad45a" providerId="ADAL" clId="{A57800CA-4072-4B01-99D3-B58C761CB754}" dt="2025-07-25T13:25:08.855" v="294" actId="1076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A25DEC5B-0D96-964B-8538-CEEE1D0657B9}"/>
    <pc:docChg chg="modSld">
      <pc:chgData name="Míriam Fernández González" userId="S::mfernandez@idibell.cat::352a0393-308e-4058-8495-78b481706071" providerId="AD" clId="Web-{A25DEC5B-0D96-964B-8538-CEEE1D0657B9}" dt="2025-07-24T14:40:25.906" v="11"/>
      <pc:docMkLst>
        <pc:docMk/>
      </pc:docMkLst>
      <pc:sldChg chg="delSp modSp">
        <pc:chgData name="Míriam Fernández González" userId="S::mfernandez@idibell.cat::352a0393-308e-4058-8495-78b481706071" providerId="AD" clId="Web-{A25DEC5B-0D96-964B-8538-CEEE1D0657B9}" dt="2025-07-24T14:40:15.109" v="5" actId="20577"/>
        <pc:sldMkLst>
          <pc:docMk/>
          <pc:sldMk cId="989154112" sldId="278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09.328" v="2" actId="20577"/>
        <pc:sldMkLst>
          <pc:docMk/>
          <pc:sldMk cId="1574192415" sldId="279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20.016" v="8" actId="20577"/>
        <pc:sldMkLst>
          <pc:docMk/>
          <pc:sldMk cId="2685193683" sldId="282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25.906" v="11"/>
        <pc:sldMkLst>
          <pc:docMk/>
          <pc:sldMk cId="3959166534" sldId="283"/>
        </pc:sldMkLst>
      </pc:sldChg>
    </pc:docChg>
  </pc:docChgLst>
  <pc:docChgLst>
    <pc:chgData clId="Web-{2078CF52-1543-3A94-1FF6-FDE5A1C808B6}"/>
    <pc:docChg chg="addSld">
      <pc:chgData name="" userId="" providerId="" clId="Web-{2078CF52-1543-3A94-1FF6-FDE5A1C808B6}" dt="2025-07-25T12:42:52.619" v="0"/>
      <pc:docMkLst>
        <pc:docMk/>
      </pc:docMkLst>
      <pc:sldChg chg="add replId">
        <pc:chgData name="" userId="" providerId="" clId="Web-{2078CF52-1543-3A94-1FF6-FDE5A1C808B6}" dt="2025-07-25T12:42:52.619" v="0"/>
        <pc:sldMkLst>
          <pc:docMk/>
          <pc:sldMk cId="3846821981" sldId="297"/>
        </pc:sldMkLst>
      </pc:sldChg>
    </pc:docChg>
  </pc:docChgLst>
  <pc:docChgLst>
    <pc:chgData name="Míriam Fernández González" userId="352a0393-308e-4058-8495-78b481706071" providerId="ADAL" clId="{6CC23B6F-D564-426D-940C-C35F10A92CC4}"/>
    <pc:docChg chg="undo custSel addSld delSld modSld sldOrd">
      <pc:chgData name="Míriam Fernández González" userId="352a0393-308e-4058-8495-78b481706071" providerId="ADAL" clId="{6CC23B6F-D564-426D-940C-C35F10A92CC4}" dt="2025-07-25T13:42:06.046" v="1944" actId="20577"/>
      <pc:docMkLst>
        <pc:docMk/>
      </pc:docMkLst>
      <pc:sldChg chg="del">
        <pc:chgData name="Míriam Fernández González" userId="352a0393-308e-4058-8495-78b481706071" providerId="ADAL" clId="{6CC23B6F-D564-426D-940C-C35F10A92CC4}" dt="2025-07-23T10:06:54.583" v="1" actId="47"/>
        <pc:sldMkLst>
          <pc:docMk/>
          <pc:sldMk cId="2406273178" sldId="256"/>
        </pc:sldMkLst>
      </pc:sldChg>
      <pc:sldChg chg="addSp delSp modSp new mod">
        <pc:chgData name="Míriam Fernández González" userId="352a0393-308e-4058-8495-78b481706071" providerId="ADAL" clId="{6CC23B6F-D564-426D-940C-C35F10A92CC4}" dt="2025-07-25T12:48:25.066" v="1673" actId="1076"/>
        <pc:sldMkLst>
          <pc:docMk/>
          <pc:sldMk cId="1899656772" sldId="257"/>
        </pc:sldMkLst>
      </pc:sldChg>
      <pc:sldChg chg="add del">
        <pc:chgData name="Míriam Fernández González" userId="352a0393-308e-4058-8495-78b481706071" providerId="ADAL" clId="{6CC23B6F-D564-426D-940C-C35F10A92CC4}" dt="2025-07-23T10:08:25.607" v="29" actId="47"/>
        <pc:sldMkLst>
          <pc:docMk/>
          <pc:sldMk cId="4080752078" sldId="258"/>
        </pc:sldMkLst>
      </pc:sldChg>
      <pc:sldChg chg="add del">
        <pc:chgData name="Míriam Fernández González" userId="352a0393-308e-4058-8495-78b481706071" providerId="ADAL" clId="{6CC23B6F-D564-426D-940C-C35F10A92CC4}" dt="2025-07-23T10:08:26.158" v="30" actId="47"/>
        <pc:sldMkLst>
          <pc:docMk/>
          <pc:sldMk cId="3580857271" sldId="259"/>
        </pc:sldMkLst>
      </pc:sldChg>
      <pc:sldChg chg="add del">
        <pc:chgData name="Míriam Fernández González" userId="352a0393-308e-4058-8495-78b481706071" providerId="ADAL" clId="{6CC23B6F-D564-426D-940C-C35F10A92CC4}" dt="2025-07-23T10:08:26.661" v="31" actId="47"/>
        <pc:sldMkLst>
          <pc:docMk/>
          <pc:sldMk cId="2234829343" sldId="260"/>
        </pc:sldMkLst>
      </pc:sldChg>
      <pc:sldChg chg="add del">
        <pc:chgData name="Míriam Fernández González" userId="352a0393-308e-4058-8495-78b481706071" providerId="ADAL" clId="{6CC23B6F-D564-426D-940C-C35F10A92CC4}" dt="2025-07-23T10:08:26.959" v="32" actId="47"/>
        <pc:sldMkLst>
          <pc:docMk/>
          <pc:sldMk cId="862921727" sldId="261"/>
        </pc:sldMkLst>
      </pc:sldChg>
      <pc:sldChg chg="add del">
        <pc:chgData name="Míriam Fernández González" userId="352a0393-308e-4058-8495-78b481706071" providerId="ADAL" clId="{6CC23B6F-D564-426D-940C-C35F10A92CC4}" dt="2025-07-23T10:08:27.211" v="33" actId="47"/>
        <pc:sldMkLst>
          <pc:docMk/>
          <pc:sldMk cId="3804607996" sldId="262"/>
        </pc:sldMkLst>
      </pc:sldChg>
      <pc:sldChg chg="add del">
        <pc:chgData name="Míriam Fernández González" userId="352a0393-308e-4058-8495-78b481706071" providerId="ADAL" clId="{6CC23B6F-D564-426D-940C-C35F10A92CC4}" dt="2025-07-23T10:08:27.431" v="34" actId="47"/>
        <pc:sldMkLst>
          <pc:docMk/>
          <pc:sldMk cId="4226813653" sldId="263"/>
        </pc:sldMkLst>
      </pc:sldChg>
      <pc:sldChg chg="add del">
        <pc:chgData name="Míriam Fernández González" userId="352a0393-308e-4058-8495-78b481706071" providerId="ADAL" clId="{6CC23B6F-D564-426D-940C-C35F10A92CC4}" dt="2025-07-23T10:08:27.626" v="35" actId="47"/>
        <pc:sldMkLst>
          <pc:docMk/>
          <pc:sldMk cId="1753621800" sldId="264"/>
        </pc:sldMkLst>
      </pc:sldChg>
      <pc:sldChg chg="add del">
        <pc:chgData name="Míriam Fernández González" userId="352a0393-308e-4058-8495-78b481706071" providerId="ADAL" clId="{6CC23B6F-D564-426D-940C-C35F10A92CC4}" dt="2025-07-23T10:08:27.807" v="36" actId="47"/>
        <pc:sldMkLst>
          <pc:docMk/>
          <pc:sldMk cId="3900698960" sldId="265"/>
        </pc:sldMkLst>
      </pc:sldChg>
      <pc:sldChg chg="add del">
        <pc:chgData name="Míriam Fernández González" userId="352a0393-308e-4058-8495-78b481706071" providerId="ADAL" clId="{6CC23B6F-D564-426D-940C-C35F10A92CC4}" dt="2025-07-23T10:08:27.980" v="37" actId="47"/>
        <pc:sldMkLst>
          <pc:docMk/>
          <pc:sldMk cId="2255315707" sldId="266"/>
        </pc:sldMkLst>
      </pc:sldChg>
      <pc:sldChg chg="add del">
        <pc:chgData name="Míriam Fernández González" userId="352a0393-308e-4058-8495-78b481706071" providerId="ADAL" clId="{6CC23B6F-D564-426D-940C-C35F10A92CC4}" dt="2025-07-23T10:08:28.184" v="38" actId="47"/>
        <pc:sldMkLst>
          <pc:docMk/>
          <pc:sldMk cId="1476492493" sldId="267"/>
        </pc:sldMkLst>
      </pc:sldChg>
      <pc:sldChg chg="add del">
        <pc:chgData name="Míriam Fernández González" userId="352a0393-308e-4058-8495-78b481706071" providerId="ADAL" clId="{6CC23B6F-D564-426D-940C-C35F10A92CC4}" dt="2025-07-23T10:08:28.466" v="39" actId="47"/>
        <pc:sldMkLst>
          <pc:docMk/>
          <pc:sldMk cId="835741156" sldId="268"/>
        </pc:sldMkLst>
      </pc:sldChg>
      <pc:sldChg chg="add del">
        <pc:chgData name="Míriam Fernández González" userId="352a0393-308e-4058-8495-78b481706071" providerId="ADAL" clId="{6CC23B6F-D564-426D-940C-C35F10A92CC4}" dt="2025-07-23T10:08:29.142" v="40" actId="47"/>
        <pc:sldMkLst>
          <pc:docMk/>
          <pc:sldMk cId="1533935708" sldId="269"/>
        </pc:sldMkLst>
      </pc:sldChg>
      <pc:sldChg chg="add del ord">
        <pc:chgData name="Míriam Fernández González" userId="352a0393-308e-4058-8495-78b481706071" providerId="ADAL" clId="{6CC23B6F-D564-426D-940C-C35F10A92CC4}" dt="2025-07-23T10:08:22.656" v="28" actId="47"/>
        <pc:sldMkLst>
          <pc:docMk/>
          <pc:sldMk cId="3361930825" sldId="270"/>
        </pc:sldMkLst>
      </pc:sldChg>
      <pc:sldChg chg="add del">
        <pc:chgData name="Míriam Fernández González" userId="352a0393-308e-4058-8495-78b481706071" providerId="ADAL" clId="{6CC23B6F-D564-426D-940C-C35F10A92CC4}" dt="2025-07-23T10:08:18.413" v="25" actId="47"/>
        <pc:sldMkLst>
          <pc:docMk/>
          <pc:sldMk cId="234280666" sldId="271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8:24.392" v="1505" actId="1076"/>
        <pc:sldMkLst>
          <pc:docMk/>
          <pc:sldMk cId="2286362297" sldId="272"/>
        </pc:sldMkLst>
      </pc:sldChg>
      <pc:sldChg chg="addSp delSp modSp add mod">
        <pc:chgData name="Míriam Fernández González" userId="352a0393-308e-4058-8495-78b481706071" providerId="ADAL" clId="{6CC23B6F-D564-426D-940C-C35F10A92CC4}" dt="2025-07-23T10:25:05.490" v="402" actId="1076"/>
        <pc:sldMkLst>
          <pc:docMk/>
          <pc:sldMk cId="3604231316" sldId="273"/>
        </pc:sldMkLst>
      </pc:sldChg>
      <pc:sldChg chg="addSp delSp modSp add mod">
        <pc:chgData name="Míriam Fernández González" userId="352a0393-308e-4058-8495-78b481706071" providerId="ADAL" clId="{6CC23B6F-D564-426D-940C-C35F10A92CC4}" dt="2025-07-23T10:25:37.465" v="407" actId="1076"/>
        <pc:sldMkLst>
          <pc:docMk/>
          <pc:sldMk cId="2525473906" sldId="274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9:09.219" v="1514" actId="1076"/>
        <pc:sldMkLst>
          <pc:docMk/>
          <pc:sldMk cId="98097563" sldId="275"/>
        </pc:sldMkLst>
      </pc:sldChg>
      <pc:sldChg chg="addSp delSp modSp add mod">
        <pc:chgData name="Míriam Fernández González" userId="352a0393-308e-4058-8495-78b481706071" providerId="ADAL" clId="{6CC23B6F-D564-426D-940C-C35F10A92CC4}" dt="2025-07-25T13:42:06.046" v="1944" actId="20577"/>
        <pc:sldMkLst>
          <pc:docMk/>
          <pc:sldMk cId="849156004" sldId="276"/>
        </pc:sldMkLst>
      </pc:sldChg>
      <pc:sldChg chg="addSp modSp add mod ord">
        <pc:chgData name="Míriam Fernández González" userId="352a0393-308e-4058-8495-78b481706071" providerId="ADAL" clId="{6CC23B6F-D564-426D-940C-C35F10A92CC4}" dt="2025-07-23T15:10:13.896" v="1530" actId="732"/>
        <pc:sldMkLst>
          <pc:docMk/>
          <pc:sldMk cId="631989269" sldId="277"/>
        </pc:sldMkLst>
      </pc:sldChg>
      <pc:sldChg chg="add del">
        <pc:chgData name="Míriam Fernández González" userId="352a0393-308e-4058-8495-78b481706071" providerId="ADAL" clId="{6CC23B6F-D564-426D-940C-C35F10A92CC4}" dt="2025-07-23T10:28:22.542" v="472" actId="47"/>
        <pc:sldMkLst>
          <pc:docMk/>
          <pc:sldMk cId="1700075419" sldId="277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6:16.325" v="1797" actId="1076"/>
        <pc:sldMkLst>
          <pc:docMk/>
          <pc:sldMk cId="989154112" sldId="278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5:38.084" v="1784" actId="1076"/>
        <pc:sldMkLst>
          <pc:docMk/>
          <pc:sldMk cId="1574192415" sldId="279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11:03.884" v="1543" actId="1076"/>
        <pc:sldMkLst>
          <pc:docMk/>
          <pc:sldMk cId="3766750973" sldId="280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11:18.375" v="1546" actId="1076"/>
        <pc:sldMkLst>
          <pc:docMk/>
          <pc:sldMk cId="3324629129" sldId="281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8:08.500" v="1887" actId="1076"/>
        <pc:sldMkLst>
          <pc:docMk/>
          <pc:sldMk cId="2685193683" sldId="282"/>
        </pc:sldMkLst>
      </pc:sldChg>
      <pc:sldChg chg="add del">
        <pc:chgData name="Míriam Fernández González" userId="352a0393-308e-4058-8495-78b481706071" providerId="ADAL" clId="{6CC23B6F-D564-426D-940C-C35F10A92CC4}" dt="2025-07-23T10:40:15.154" v="784" actId="47"/>
        <pc:sldMkLst>
          <pc:docMk/>
          <pc:sldMk cId="3650244235" sldId="282"/>
        </pc:sldMkLst>
      </pc:sldChg>
      <pc:sldChg chg="addSp delSp modSp add mod">
        <pc:chgData name="Míriam Fernández González" userId="352a0393-308e-4058-8495-78b481706071" providerId="ADAL" clId="{6CC23B6F-D564-426D-940C-C35F10A92CC4}" dt="2025-07-25T13:38:50.567" v="1898" actId="14100"/>
        <pc:sldMkLst>
          <pc:docMk/>
          <pc:sldMk cId="3959166534" sldId="283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6:28.343" v="1488" actId="1076"/>
        <pc:sldMkLst>
          <pc:docMk/>
          <pc:sldMk cId="640523941" sldId="284"/>
        </pc:sldMkLst>
      </pc:sldChg>
      <pc:sldChg chg="addSp delSp modSp add del mod">
        <pc:chgData name="Míriam Fernández González" userId="352a0393-308e-4058-8495-78b481706071" providerId="ADAL" clId="{6CC23B6F-D564-426D-940C-C35F10A92CC4}" dt="2025-07-23T11:07:57.119" v="1087" actId="47"/>
        <pc:sldMkLst>
          <pc:docMk/>
          <pc:sldMk cId="2552082302" sldId="285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15.365" v="1494" actId="1076"/>
        <pc:sldMkLst>
          <pc:docMk/>
          <pc:sldMk cId="2388881966" sldId="286"/>
        </pc:sldMkLst>
      </pc:sldChg>
      <pc:sldChg chg="delSp modSp add del mod">
        <pc:chgData name="Míriam Fernández González" userId="352a0393-308e-4058-8495-78b481706071" providerId="ADAL" clId="{6CC23B6F-D564-426D-940C-C35F10A92CC4}" dt="2025-07-23T11:09:33.386" v="1121" actId="47"/>
        <pc:sldMkLst>
          <pc:docMk/>
          <pc:sldMk cId="872468030" sldId="287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6:34.939" v="1490" actId="1076"/>
        <pc:sldMkLst>
          <pc:docMk/>
          <pc:sldMk cId="1854992774" sldId="288"/>
        </pc:sldMkLst>
      </pc:sldChg>
      <pc:sldChg chg="delSp modSp add del mod">
        <pc:chgData name="Míriam Fernández González" userId="352a0393-308e-4058-8495-78b481706071" providerId="ADAL" clId="{6CC23B6F-D564-426D-940C-C35F10A92CC4}" dt="2025-07-23T14:58:21.220" v="1349" actId="47"/>
        <pc:sldMkLst>
          <pc:docMk/>
          <pc:sldMk cId="944466747" sldId="289"/>
        </pc:sldMkLst>
      </pc:sldChg>
      <pc:sldChg chg="delSp modSp add del mod">
        <pc:chgData name="Míriam Fernández González" userId="352a0393-308e-4058-8495-78b481706071" providerId="ADAL" clId="{6CC23B6F-D564-426D-940C-C35F10A92CC4}" dt="2025-07-23T11:17:00.464" v="1307" actId="47"/>
        <pc:sldMkLst>
          <pc:docMk/>
          <pc:sldMk cId="699899518" sldId="290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42.025" v="1498" actId="14100"/>
        <pc:sldMkLst>
          <pc:docMk/>
          <pc:sldMk cId="3714277399" sldId="291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7:55.238" v="1499"/>
        <pc:sldMkLst>
          <pc:docMk/>
          <pc:sldMk cId="3491293808" sldId="292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26.903" v="1496" actId="1076"/>
        <pc:sldMkLst>
          <pc:docMk/>
          <pc:sldMk cId="1938919551" sldId="293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57.744" v="1500"/>
        <pc:sldMkLst>
          <pc:docMk/>
          <pc:sldMk cId="2278150265" sldId="294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8:08.012" v="1501"/>
        <pc:sldMkLst>
          <pc:docMk/>
          <pc:sldMk cId="3333836771" sldId="295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8:10.319" v="1502"/>
        <pc:sldMkLst>
          <pc:docMk/>
          <pc:sldMk cId="3104352323" sldId="296"/>
        </pc:sldMkLst>
      </pc:sldChg>
      <pc:sldChg chg="addSp delSp modSp new del mod">
        <pc:chgData name="Míriam Fernández González" userId="352a0393-308e-4058-8495-78b481706071" providerId="ADAL" clId="{6CC23B6F-D564-426D-940C-C35F10A92CC4}" dt="2025-07-23T15:02:36.537" v="1431" actId="47"/>
        <pc:sldMkLst>
          <pc:docMk/>
          <pc:sldMk cId="479128856" sldId="297"/>
        </pc:sldMkLst>
      </pc:sldChg>
      <pc:sldChg chg="addSp modSp mod">
        <pc:chgData name="Míriam Fernández González" userId="352a0393-308e-4058-8495-78b481706071" providerId="ADAL" clId="{6CC23B6F-D564-426D-940C-C35F10A92CC4}" dt="2025-07-25T12:48:07.213" v="1669" actId="1076"/>
        <pc:sldMkLst>
          <pc:docMk/>
          <pc:sldMk cId="3846821981" sldId="297"/>
        </pc:sldMkLst>
      </pc:sldChg>
      <pc:sldChg chg="addSp delSp modSp mod">
        <pc:chgData name="Míriam Fernández González" userId="352a0393-308e-4058-8495-78b481706071" providerId="ADAL" clId="{6CC23B6F-D564-426D-940C-C35F10A92CC4}" dt="2025-07-25T12:48:34.066" v="1678" actId="1036"/>
        <pc:sldMkLst>
          <pc:docMk/>
          <pc:sldMk cId="3507912059" sldId="298"/>
        </pc:sldMkLst>
      </pc:sldChg>
      <pc:sldChg chg="addSp delSp modSp mod">
        <pc:chgData name="Míriam Fernández González" userId="352a0393-308e-4058-8495-78b481706071" providerId="ADAL" clId="{6CC23B6F-D564-426D-940C-C35F10A92CC4}" dt="2025-07-25T13:39:30.415" v="1907" actId="1076"/>
        <pc:sldMkLst>
          <pc:docMk/>
          <pc:sldMk cId="1510078259" sldId="299"/>
        </pc:sldMkLst>
      </pc:sldChg>
      <pc:sldChg chg="addSp delSp modSp mod">
        <pc:chgData name="Míriam Fernández González" userId="352a0393-308e-4058-8495-78b481706071" providerId="ADAL" clId="{6CC23B6F-D564-426D-940C-C35F10A92CC4}" dt="2025-07-25T13:40:05.751" v="1930" actId="1036"/>
        <pc:sldMkLst>
          <pc:docMk/>
          <pc:sldMk cId="1256841142" sldId="300"/>
        </pc:sldMkLst>
      </pc:sldChg>
      <pc:sldChg chg="modSp mod">
        <pc:chgData name="Míriam Fernández González" userId="352a0393-308e-4058-8495-78b481706071" providerId="ADAL" clId="{6CC23B6F-D564-426D-940C-C35F10A92CC4}" dt="2025-07-25T13:33:06.576" v="1682" actId="20577"/>
        <pc:sldMkLst>
          <pc:docMk/>
          <pc:sldMk cId="1296663075" sldId="301"/>
        </pc:sldMkLst>
      </pc:sldChg>
      <pc:sldChg chg="modSp mod">
        <pc:chgData name="Míriam Fernández González" userId="352a0393-308e-4058-8495-78b481706071" providerId="ADAL" clId="{6CC23B6F-D564-426D-940C-C35F10A92CC4}" dt="2025-07-25T13:33:37.413" v="1694" actId="20577"/>
        <pc:sldMkLst>
          <pc:docMk/>
          <pc:sldMk cId="2571517090" sldId="302"/>
        </pc:sldMkLst>
      </pc:sldChg>
      <pc:sldChg chg="modSp mod">
        <pc:chgData name="Míriam Fernández González" userId="352a0393-308e-4058-8495-78b481706071" providerId="ADAL" clId="{6CC23B6F-D564-426D-940C-C35F10A92CC4}" dt="2025-07-25T13:33:26.110" v="1690" actId="20577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98EE4D30-4875-04A6-BF8A-D2A056950045}"/>
    <pc:docChg chg="modSld">
      <pc:chgData name="Míriam Fernández González" userId="S::mfernandez@idibell.cat::352a0393-308e-4058-8495-78b481706071" providerId="AD" clId="Web-{98EE4D30-4875-04A6-BF8A-D2A056950045}" dt="2025-07-25T13:30:24.917" v="14" actId="1076"/>
      <pc:docMkLst>
        <pc:docMk/>
      </pc:docMkLst>
      <pc:sldChg chg="modSp">
        <pc:chgData name="Míriam Fernández González" userId="S::mfernandez@idibell.cat::352a0393-308e-4058-8495-78b481706071" providerId="AD" clId="Web-{98EE4D30-4875-04A6-BF8A-D2A056950045}" dt="2025-07-25T12:54:33.628" v="0" actId="1076"/>
        <pc:sldMkLst>
          <pc:docMk/>
          <pc:sldMk cId="3604231316" sldId="273"/>
        </pc:sldMkLst>
      </pc:sldChg>
      <pc:sldChg chg="addSp delSp modSp">
        <pc:chgData name="Míriam Fernández González" userId="S::mfernandez@idibell.cat::352a0393-308e-4058-8495-78b481706071" providerId="AD" clId="Web-{98EE4D30-4875-04A6-BF8A-D2A056950045}" dt="2025-07-25T13:30:24.917" v="14" actId="1076"/>
        <pc:sldMkLst>
          <pc:docMk/>
          <pc:sldMk cId="2685193683" sldId="282"/>
        </pc:sldMkLst>
      </pc:sldChg>
    </pc:docChg>
  </pc:docChgLst>
  <pc:docChgLst>
    <pc:chgData name="Jacopo Boni" userId="3468928e-f576-476d-811b-ea8091bad45a" providerId="ADAL" clId="{F8328929-8069-4A27-BC10-04899D47FBC5}"/>
    <pc:docChg chg="delSld">
      <pc:chgData name="Jacopo Boni" userId="3468928e-f576-476d-811b-ea8091bad45a" providerId="ADAL" clId="{F8328929-8069-4A27-BC10-04899D47FBC5}" dt="2025-09-08T15:52:54.207" v="0" actId="47"/>
      <pc:docMkLst>
        <pc:docMk/>
      </pc:docMkLst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1899656772" sldId="257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2286362297" sldId="272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604231316" sldId="273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2525473906" sldId="274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98097563" sldId="275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849156004" sldId="276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631989269" sldId="277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989154112" sldId="278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1574192415" sldId="279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766750973" sldId="280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324629129" sldId="281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640523941" sldId="284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2388881966" sldId="286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1854992774" sldId="288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714277399" sldId="291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491293808" sldId="292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1938919551" sldId="293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2278150265" sldId="294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333836771" sldId="295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104352323" sldId="296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846821981" sldId="297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507912059" sldId="298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1296663075" sldId="301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2571517090" sldId="302"/>
        </pc:sldMkLst>
      </pc:sldChg>
      <pc:sldChg chg="del">
        <pc:chgData name="Jacopo Boni" userId="3468928e-f576-476d-811b-ea8091bad45a" providerId="ADAL" clId="{F8328929-8069-4A27-BC10-04899D47FBC5}" dt="2025-09-08T15:52:54.207" v="0" actId="47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2078CF52-1543-3A94-1FF6-FDE5A1C808B6}"/>
    <pc:docChg chg="addSld modSld sldOrd">
      <pc:chgData name="Míriam Fernández González" userId="S::mfernandez@idibell.cat::352a0393-308e-4058-8495-78b481706071" providerId="AD" clId="Web-{2078CF52-1543-3A94-1FF6-FDE5A1C808B6}" dt="2025-07-25T12:43:24.933" v="2"/>
      <pc:docMkLst>
        <pc:docMk/>
      </pc:docMkLst>
      <pc:sldChg chg="addSp modSp ord">
        <pc:chgData name="Míriam Fernández González" userId="S::mfernandez@idibell.cat::352a0393-308e-4058-8495-78b481706071" providerId="AD" clId="Web-{2078CF52-1543-3A94-1FF6-FDE5A1C808B6}" dt="2025-07-25T12:43:24.933" v="2"/>
        <pc:sldMkLst>
          <pc:docMk/>
          <pc:sldMk cId="1899656772" sldId="257"/>
        </pc:sldMkLst>
      </pc:sldChg>
      <pc:sldChg chg="add replId">
        <pc:chgData name="Míriam Fernández González" userId="S::mfernandez@idibell.cat::352a0393-308e-4058-8495-78b481706071" providerId="AD" clId="Web-{2078CF52-1543-3A94-1FF6-FDE5A1C808B6}" dt="2025-07-25T12:42:53.666" v="0"/>
        <pc:sldMkLst>
          <pc:docMk/>
          <pc:sldMk cId="3507912059" sldId="29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8191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1863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5096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8174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9700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9029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2394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0658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82375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0449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603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3118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4DC7EF2-12CE-957C-AEF5-A9EE2E02E57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 descr="Imagen que contiene interior, tabla, computadora, microondas&#10;&#10;El contenido generado por IA puede ser incorrecto.">
            <a:extLst>
              <a:ext uri="{FF2B5EF4-FFF2-40B4-BE49-F238E27FC236}">
                <a16:creationId xmlns:a16="http://schemas.microsoft.com/office/drawing/2014/main" id="{A8E311AA-0973-4652-E03D-A71ECDE7E2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4628" y="883970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D98FEA8F-0F53-6EDF-98B6-E283AB1593FF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 rtlCol="0" anchor="t">
            <a:spAutoFit/>
          </a:bodyPr>
          <a:lstStyle/>
          <a:p>
            <a:r>
              <a:rPr lang="en-US"/>
              <a:t>5C</a:t>
            </a:r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id="{983ACE9F-5916-5248-288D-D3EDD2557F69}"/>
              </a:ext>
            </a:extLst>
          </p:cNvPr>
          <p:cNvSpPr/>
          <p:nvPr/>
        </p:nvSpPr>
        <p:spPr>
          <a:xfrm>
            <a:off x="4049084" y="2240280"/>
            <a:ext cx="3183820" cy="587887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AD30F56E-EBAC-1029-5647-359BEF7FA838}"/>
              </a:ext>
            </a:extLst>
          </p:cNvPr>
          <p:cNvSpPr txBox="1"/>
          <p:nvPr/>
        </p:nvSpPr>
        <p:spPr>
          <a:xfrm rot="16200000">
            <a:off x="5444650" y="-806396"/>
            <a:ext cx="1784480" cy="4308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-R661P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IP 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 IP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-R661P IP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63F861B-868D-67EB-ABDD-FD3282F04E6E}"/>
              </a:ext>
            </a:extLst>
          </p:cNvPr>
          <p:cNvSpPr txBox="1"/>
          <p:nvPr/>
        </p:nvSpPr>
        <p:spPr>
          <a:xfrm>
            <a:off x="9254628" y="2349557"/>
            <a:ext cx="1492524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FLAG-FGFR1</a:t>
            </a:r>
          </a:p>
        </p:txBody>
      </p:sp>
      <p:pic>
        <p:nvPicPr>
          <p:cNvPr id="4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4D563A5C-A7F6-C0C6-0E31-A1750DAAE43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7508" r="34356" b="63257"/>
          <a:stretch>
            <a:fillRect/>
          </a:stretch>
        </p:blipFill>
        <p:spPr bwMode="auto">
          <a:xfrm>
            <a:off x="1823868" y="2089174"/>
            <a:ext cx="1732121" cy="13398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851936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65E128-A950-01A8-8526-04D109D4FFC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n 16" descr="Texto&#10;&#10;El contenido generado por IA puede ser incorrecto.">
            <a:extLst>
              <a:ext uri="{FF2B5EF4-FFF2-40B4-BE49-F238E27FC236}">
                <a16:creationId xmlns:a16="http://schemas.microsoft.com/office/drawing/2014/main" id="{5DFB4E71-044A-A4BF-E7C9-2DE6386318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3705" y="810818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9F697F62-01B6-702A-C5D8-9187D741D8DE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 rtlCol="0" anchor="t">
            <a:spAutoFit/>
          </a:bodyPr>
          <a:lstStyle/>
          <a:p>
            <a:r>
              <a:rPr lang="en-US"/>
              <a:t>5C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C40CAE04-B9BE-33ED-5A02-474A75ADEBEB}"/>
              </a:ext>
            </a:extLst>
          </p:cNvPr>
          <p:cNvSpPr txBox="1"/>
          <p:nvPr/>
        </p:nvSpPr>
        <p:spPr>
          <a:xfrm>
            <a:off x="1186248" y="2685599"/>
            <a:ext cx="999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pFGFR1</a:t>
            </a:r>
          </a:p>
        </p:txBody>
      </p:sp>
      <p:pic>
        <p:nvPicPr>
          <p:cNvPr id="18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D5FC9AC9-3F99-9B02-318B-8EBC45BF5A3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8221999" y="1931067"/>
            <a:ext cx="1700159" cy="16625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ángulo 3">
            <a:extLst>
              <a:ext uri="{FF2B5EF4-FFF2-40B4-BE49-F238E27FC236}">
                <a16:creationId xmlns:a16="http://schemas.microsoft.com/office/drawing/2014/main" id="{5D99A33B-08D5-7121-EA42-F1640A4595FC}"/>
              </a:ext>
            </a:extLst>
          </p:cNvPr>
          <p:cNvSpPr/>
          <p:nvPr/>
        </p:nvSpPr>
        <p:spPr>
          <a:xfrm>
            <a:off x="4707452" y="2258568"/>
            <a:ext cx="3183820" cy="587887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747B88D7-8A2A-EEFD-0E58-040249585E75}"/>
              </a:ext>
            </a:extLst>
          </p:cNvPr>
          <p:cNvSpPr txBox="1"/>
          <p:nvPr/>
        </p:nvSpPr>
        <p:spPr>
          <a:xfrm rot="16200000">
            <a:off x="6103018" y="-788108"/>
            <a:ext cx="1784480" cy="4308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-R661P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IP 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 IP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-R661P IP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91665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3F459A1-E2AB-748F-8D8D-A3BB34D8B36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 descr="Imagen que contiene interior, libro, tabla, computadora&#10;&#10;El contenido generado por IA puede ser incorrecto.">
            <a:extLst>
              <a:ext uri="{FF2B5EF4-FFF2-40B4-BE49-F238E27FC236}">
                <a16:creationId xmlns:a16="http://schemas.microsoft.com/office/drawing/2014/main" id="{C17A1830-5AD5-6521-4497-3C9274AADE8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0902" y="947852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2E5BDFBD-B294-383B-10E3-B4DBDF20367E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 rtlCol="0" anchor="t">
            <a:spAutoFit/>
          </a:bodyPr>
          <a:lstStyle/>
          <a:p>
            <a:r>
              <a:rPr lang="en-US"/>
              <a:t>5C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D89F8E2D-A276-FD97-BF08-141FA6C6FE64}"/>
              </a:ext>
            </a:extLst>
          </p:cNvPr>
          <p:cNvSpPr txBox="1"/>
          <p:nvPr/>
        </p:nvSpPr>
        <p:spPr>
          <a:xfrm>
            <a:off x="1791658" y="2020698"/>
            <a:ext cx="714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solidFill>
                  <a:srgbClr val="FF0000"/>
                </a:solidFill>
              </a:rPr>
              <a:t>PLCy</a:t>
            </a:r>
            <a:endParaRPr lang="en-US" b="1" dirty="0">
              <a:solidFill>
                <a:srgbClr val="FF0000"/>
              </a:solidFill>
            </a:endParaRPr>
          </a:p>
        </p:txBody>
      </p:sp>
      <p:pic>
        <p:nvPicPr>
          <p:cNvPr id="18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AACB374E-FF98-A4A0-314D-FF606BE317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8943104" y="1450831"/>
            <a:ext cx="1920917" cy="18783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ángulo 3">
            <a:extLst>
              <a:ext uri="{FF2B5EF4-FFF2-40B4-BE49-F238E27FC236}">
                <a16:creationId xmlns:a16="http://schemas.microsoft.com/office/drawing/2014/main" id="{ADDA36AB-0558-0F1C-FF38-FFE722B0AA98}"/>
              </a:ext>
            </a:extLst>
          </p:cNvPr>
          <p:cNvSpPr/>
          <p:nvPr/>
        </p:nvSpPr>
        <p:spPr>
          <a:xfrm>
            <a:off x="5402396" y="1840092"/>
            <a:ext cx="3183820" cy="587887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BE346EDA-0113-1876-8CEA-95F0166D0316}"/>
              </a:ext>
            </a:extLst>
          </p:cNvPr>
          <p:cNvSpPr txBox="1"/>
          <p:nvPr/>
        </p:nvSpPr>
        <p:spPr>
          <a:xfrm rot="16200000">
            <a:off x="6797962" y="-1206584"/>
            <a:ext cx="1784480" cy="4308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-R661P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IP 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 IP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-R661P IP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00782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40D3135-19E0-3220-CB77-85E2B94DA3B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 descr="Texto, Pizarra&#10;&#10;El contenido generado por IA puede ser incorrecto.">
            <a:extLst>
              <a:ext uri="{FF2B5EF4-FFF2-40B4-BE49-F238E27FC236}">
                <a16:creationId xmlns:a16="http://schemas.microsoft.com/office/drawing/2014/main" id="{6D5E558C-7462-6801-C1A5-777B214832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6816" y="810818"/>
            <a:ext cx="7200000" cy="523636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9E54CD04-B2F5-F90C-D0E7-0A83D58CFDD7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 rtlCol="0" anchor="t">
            <a:spAutoFit/>
          </a:bodyPr>
          <a:lstStyle/>
          <a:p>
            <a:r>
              <a:rPr lang="en-US"/>
              <a:t>5C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890AD5D7-71C3-02D3-2E70-23EEA8A92788}"/>
              </a:ext>
            </a:extLst>
          </p:cNvPr>
          <p:cNvSpPr txBox="1"/>
          <p:nvPr/>
        </p:nvSpPr>
        <p:spPr>
          <a:xfrm>
            <a:off x="1387416" y="2282903"/>
            <a:ext cx="849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solidFill>
                  <a:srgbClr val="FF0000"/>
                </a:solidFill>
              </a:rPr>
              <a:t>pPLCy</a:t>
            </a:r>
            <a:endParaRPr lang="en-US" b="1" dirty="0">
              <a:solidFill>
                <a:srgbClr val="FF0000"/>
              </a:solidFill>
            </a:endParaRPr>
          </a:p>
        </p:txBody>
      </p:sp>
      <p:pic>
        <p:nvPicPr>
          <p:cNvPr id="18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7E376355-C8A1-58F0-2BA5-2160F0C318F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8120144" y="1602828"/>
            <a:ext cx="1920917" cy="18783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ángulo 3">
            <a:extLst>
              <a:ext uri="{FF2B5EF4-FFF2-40B4-BE49-F238E27FC236}">
                <a16:creationId xmlns:a16="http://schemas.microsoft.com/office/drawing/2014/main" id="{A0A5B4CB-F2AC-76B3-5570-063CAC67D41D}"/>
              </a:ext>
            </a:extLst>
          </p:cNvPr>
          <p:cNvSpPr/>
          <p:nvPr/>
        </p:nvSpPr>
        <p:spPr>
          <a:xfrm>
            <a:off x="4652588" y="2130054"/>
            <a:ext cx="3183820" cy="587887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B5F61B38-1DB2-8C87-3DF1-4F86C7A3EADE}"/>
              </a:ext>
            </a:extLst>
          </p:cNvPr>
          <p:cNvSpPr txBox="1"/>
          <p:nvPr/>
        </p:nvSpPr>
        <p:spPr>
          <a:xfrm rot="16200000">
            <a:off x="6048154" y="-916622"/>
            <a:ext cx="1784480" cy="4308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-R661P input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WT IP 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 </a:t>
            </a: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 IP 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r>
              <a:rPr lang="en-US" sz="1400" b="1" dirty="0">
                <a:solidFill>
                  <a:srgbClr val="FF0000"/>
                </a:solidFill>
              </a:rPr>
              <a:t>N546K-R661P IP</a:t>
            </a: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  <a:p>
            <a:pPr>
              <a:spcBef>
                <a:spcPts val="400"/>
              </a:spcBef>
            </a:pPr>
            <a:endParaRPr 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568411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b06b1ac-b6cc-4c25-bfb7-551e20c80d5c">
      <Terms xmlns="http://schemas.microsoft.com/office/infopath/2007/PartnerControls"/>
    </lcf76f155ced4ddcb4097134ff3c332f>
    <_ip_UnifiedCompliancePolicyUIAction xmlns="http://schemas.microsoft.com/sharepoint/v3" xsi:nil="true"/>
    <_ip_UnifiedCompliancePolicyProperties xmlns="http://schemas.microsoft.com/sharepoint/v3" xsi:nil="true"/>
    <experiment xmlns="3b06b1ac-b6cc-4c25-bfb7-551e20c80d5c" xsi:nil="true"/>
    <TaxCatchAll xmlns="e060ecb7-dcf7-4a45-ada8-96d79a1fb1be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82784A8EC112FF47A12A49FA34F89301" ma:contentTypeVersion="19" ma:contentTypeDescription="Crear nuevo documento." ma:contentTypeScope="" ma:versionID="3a523e80048e49ca689ccbbead60cdeb">
  <xsd:schema xmlns:xsd="http://www.w3.org/2001/XMLSchema" xmlns:xs="http://www.w3.org/2001/XMLSchema" xmlns:p="http://schemas.microsoft.com/office/2006/metadata/properties" xmlns:ns1="http://schemas.microsoft.com/sharepoint/v3" xmlns:ns2="3b06b1ac-b6cc-4c25-bfb7-551e20c80d5c" xmlns:ns3="e060ecb7-dcf7-4a45-ada8-96d79a1fb1be" targetNamespace="http://schemas.microsoft.com/office/2006/metadata/properties" ma:root="true" ma:fieldsID="bb7710ec5d278677887808aadfeb7836" ns1:_="" ns2:_="" ns3:_="">
    <xsd:import namespace="http://schemas.microsoft.com/sharepoint/v3"/>
    <xsd:import namespace="3b06b1ac-b6cc-4c25-bfb7-551e20c80d5c"/>
    <xsd:import namespace="e060ecb7-dcf7-4a45-ada8-96d79a1fb1b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DateTaken" minOccurs="0"/>
                <xsd:element ref="ns2:MediaServiceLocatio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3:SharedWithUsers" minOccurs="0"/>
                <xsd:element ref="ns3:SharedWithDetails" minOccurs="0"/>
                <xsd:element ref="ns2:experiment" minOccurs="0"/>
                <xsd:element ref="ns1:_ip_UnifiedCompliancePolicyProperties" minOccurs="0"/>
                <xsd:element ref="ns1:_ip_UnifiedCompliancePolicyUIAction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4" nillable="true" ma:displayName="Propiedades de la Directiva de cumplimiento unificado" ma:hidden="true" ma:internalName="_ip_UnifiedCompliancePolicyProperties">
      <xsd:simpleType>
        <xsd:restriction base="dms:Note"/>
      </xsd:simpleType>
    </xsd:element>
    <xsd:element name="_ip_UnifiedCompliancePolicyUIAction" ma:index="25" nillable="true" ma:displayName="Acción de IU de la Directiva de cumplimiento unificado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06b1ac-b6cc-4c25-bfb7-551e20c80d5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8" nillable="true" ma:taxonomy="true" ma:internalName="lcf76f155ced4ddcb4097134ff3c332f" ma:taxonomyFieldName="MediaServiceImageTags" ma:displayName="Etiquetas de imagen" ma:readOnly="false" ma:fieldId="{5cf76f15-5ced-4ddc-b409-7134ff3c332f}" ma:taxonomyMulti="true" ma:sspId="060dc275-4b37-4471-97cc-e467d34dad9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experiment" ma:index="23" nillable="true" ma:displayName="experiment" ma:format="Dropdown" ma:internalName="experiment">
      <xsd:simpleType>
        <xsd:restriction base="dms:Text">
          <xsd:maxLength value="255"/>
        </xsd:restriction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060ecb7-dcf7-4a45-ada8-96d79a1fb1be" elementFormDefault="qualified">
    <xsd:import namespace="http://schemas.microsoft.com/office/2006/documentManagement/types"/>
    <xsd:import namespace="http://schemas.microsoft.com/office/infopath/2007/PartnerControls"/>
    <xsd:element name="TaxCatchAll" ma:index="19" nillable="true" ma:displayName="Taxonomy Catch All Column" ma:hidden="true" ma:list="{e1f92d22-2900-48ef-9cf0-36df0f5fa8f8}" ma:internalName="TaxCatchAll" ma:showField="CatchAllData" ma:web="e060ecb7-dcf7-4a45-ada8-96d79a1fb1b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F7AEF27-12CF-4E6A-A4C3-0C70AB873B03}">
  <ds:schemaRefs>
    <ds:schemaRef ds:uri="3b06b1ac-b6cc-4c25-bfb7-551e20c80d5c"/>
    <ds:schemaRef ds:uri="e060ecb7-dcf7-4a45-ada8-96d79a1fb1be"/>
    <ds:schemaRef ds:uri="http://schemas.microsoft.com/office/2006/metadata/properties"/>
    <ds:schemaRef ds:uri="http://schemas.microsoft.com/office/infopath/2007/PartnerControls"/>
    <ds:schemaRef ds:uri="http://schemas.microsoft.com/sharepoint/v3"/>
  </ds:schemaRefs>
</ds:datastoreItem>
</file>

<file path=customXml/itemProps2.xml><?xml version="1.0" encoding="utf-8"?>
<ds:datastoreItem xmlns:ds="http://schemas.openxmlformats.org/officeDocument/2006/customXml" ds:itemID="{19958082-6C40-488A-8135-0A38B0E6EB72}">
  <ds:schemaRefs>
    <ds:schemaRef ds:uri="3b06b1ac-b6cc-4c25-bfb7-551e20c80d5c"/>
    <ds:schemaRef ds:uri="e060ecb7-dcf7-4a45-ada8-96d79a1fb1be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B975D885-2EFD-43D8-9F27-DFF974AB0B7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Panorámica</PresentationFormat>
  <Paragraphs>64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Jacopo Boni</cp:lastModifiedBy>
  <cp:revision>1</cp:revision>
  <dcterms:created xsi:type="dcterms:W3CDTF">2025-07-23T10:06:09Z</dcterms:created>
  <dcterms:modified xsi:type="dcterms:W3CDTF">2025-09-08T15:52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2784A8EC112FF47A12A49FA34F89301</vt:lpwstr>
  </property>
  <property fmtid="{D5CDD505-2E9C-101B-9397-08002B2CF9AE}" pid="3" name="MediaServiceImageTags">
    <vt:lpwstr/>
  </property>
</Properties>
</file>